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6" d="100"/>
          <a:sy n="86" d="100"/>
        </p:scale>
        <p:origin x="-3102" y="-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9DCFB-EBB8-4A96-9E6F-41F3C66F40D6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6BADF-B558-4502-9F76-9187C15024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83366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9DCFB-EBB8-4A96-9E6F-41F3C66F40D6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6BADF-B558-4502-9F76-9187C15024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0009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9DCFB-EBB8-4A96-9E6F-41F3C66F40D6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6BADF-B558-4502-9F76-9187C15024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90808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9DCFB-EBB8-4A96-9E6F-41F3C66F40D6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6BADF-B558-4502-9F76-9187C15024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20021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9DCFB-EBB8-4A96-9E6F-41F3C66F40D6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6BADF-B558-4502-9F76-9187C15024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30454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9DCFB-EBB8-4A96-9E6F-41F3C66F40D6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6BADF-B558-4502-9F76-9187C15024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91210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9DCFB-EBB8-4A96-9E6F-41F3C66F40D6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6BADF-B558-4502-9F76-9187C15024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03899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9DCFB-EBB8-4A96-9E6F-41F3C66F40D6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6BADF-B558-4502-9F76-9187C15024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40181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9DCFB-EBB8-4A96-9E6F-41F3C66F40D6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6BADF-B558-4502-9F76-9187C15024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34881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9DCFB-EBB8-4A96-9E6F-41F3C66F40D6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6BADF-B558-4502-9F76-9187C15024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66401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D9DCFB-EBB8-4A96-9E6F-41F3C66F40D6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D6BADF-B558-4502-9F76-9187C15024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1919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D9DCFB-EBB8-4A96-9E6F-41F3C66F40D6}" type="datetimeFigureOut">
              <a:rPr lang="en-US" smtClean="0"/>
              <a:t>3/3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D6BADF-B558-4502-9F76-9187C15024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76708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76364269"/>
              </p:ext>
            </p:extLst>
          </p:nvPr>
        </p:nvGraphicFramePr>
        <p:xfrm>
          <a:off x="381000" y="1600200"/>
          <a:ext cx="3105149" cy="2846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3" name="Prism 5" r:id="rId3" imgW="2875680" imgH="2086560" progId="Prism5.Document">
                  <p:embed/>
                </p:oleObj>
              </mc:Choice>
              <mc:Fallback>
                <p:oleObj name="Prism 5" r:id="rId3" imgW="2875680" imgH="208656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81000" y="1600200"/>
                        <a:ext cx="3105149" cy="2846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05671489"/>
              </p:ext>
            </p:extLst>
          </p:nvPr>
        </p:nvGraphicFramePr>
        <p:xfrm>
          <a:off x="3200400" y="1582757"/>
          <a:ext cx="3543782" cy="31416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4" name="Prism 5" r:id="rId5" imgW="2935440" imgH="2281320" progId="Prism5.Document">
                  <p:embed/>
                </p:oleObj>
              </mc:Choice>
              <mc:Fallback>
                <p:oleObj name="Prism 5" r:id="rId5" imgW="2935440" imgH="2281320" progId="Prism5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200400" y="1582757"/>
                        <a:ext cx="3543782" cy="314164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62176269"/>
              </p:ext>
            </p:extLst>
          </p:nvPr>
        </p:nvGraphicFramePr>
        <p:xfrm>
          <a:off x="1828800" y="5105400"/>
          <a:ext cx="3276600" cy="2971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5" name="Prism 5" r:id="rId7" imgW="2877120" imgH="2281320" progId="Prism5.Document">
                  <p:embed/>
                </p:oleObj>
              </mc:Choice>
              <mc:Fallback>
                <p:oleObj name="Prism 5" r:id="rId7" imgW="2877120" imgH="2281320" progId="Prism5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828800" y="5105400"/>
                        <a:ext cx="3276600" cy="29718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609600" y="1524000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dirty="0" smtClean="0"/>
              <a:t>.</a:t>
            </a:r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3509430" y="1524000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dirty="0" smtClean="0"/>
              <a:t>.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2133600" y="4888468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191000" y="304800"/>
            <a:ext cx="2454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 1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28600" y="8148934"/>
            <a:ext cx="641691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 fig1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: Box whisker plot depict the normalized spectral counts for three representative protein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ol10a1 (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,</a:t>
            </a:r>
          </a:p>
          <a:p>
            <a:pPr algn="just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Hspa5 (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,  and Vdac1 (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, respectively in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n=5) and MCDS (n=5)  condition. The mean normalized </a:t>
            </a:r>
          </a:p>
          <a:p>
            <a:pPr algn="just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pectral counts (abundances) of Col10a1 and Hspa5 proteins were significantly upregulated,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hereas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Vdac1 was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downregulated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ll graphs are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epresented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s </a:t>
            </a:r>
            <a:r>
              <a:rPr lang="en-US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an±SD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p value).   The statistical analyses were performed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using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tudent t test.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ll </a:t>
            </a:r>
            <a:r>
              <a:rPr lang="en-US" sz="1000" smtClean="0">
                <a:latin typeface="Arial" panose="020B0604020202020204" pitchFamily="34" charset="0"/>
                <a:cs typeface="Arial" panose="020B0604020202020204" pitchFamily="34" charset="0"/>
              </a:rPr>
              <a:t>presented  p-values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re statistically significant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585743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2</TotalTime>
  <Words>101</Words>
  <Application>Microsoft Office PowerPoint</Application>
  <PresentationFormat>A4 Paper (210x297 mm)</PresentationFormat>
  <Paragraphs>7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Prism 5</vt:lpstr>
      <vt:lpstr>PowerPoint Presentation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vaki Sharma</dc:creator>
  <cp:lastModifiedBy>Kudelko</cp:lastModifiedBy>
  <cp:revision>9</cp:revision>
  <dcterms:created xsi:type="dcterms:W3CDTF">2016-02-23T04:04:31Z</dcterms:created>
  <dcterms:modified xsi:type="dcterms:W3CDTF">2016-03-03T03:18:11Z</dcterms:modified>
</cp:coreProperties>
</file>